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44" autoAdjust="0"/>
    <p:restoredTop sz="94660"/>
  </p:normalViewPr>
  <p:slideViewPr>
    <p:cSldViewPr snapToGrid="0">
      <p:cViewPr varScale="1">
        <p:scale>
          <a:sx n="72" d="100"/>
          <a:sy n="72" d="100"/>
        </p:scale>
        <p:origin x="654" y="-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4128E1E-749E-41FD-84FD-99CA4F08B24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36B2BE1E-14C0-418F-BACA-B01C87EBBD9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B3AA9FE-E69C-4F2B-8638-916A9AA3E2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CD2140-D9CC-416D-9F5F-B2A0957519B5}" type="datetimeFigureOut">
              <a:rPr lang="zh-CN" altLang="en-US" smtClean="0"/>
              <a:t>2021/10/2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8047C57-BE7B-4EBE-AC5E-59094A580C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E9E0F87-F10F-421E-9E36-A02BB1A661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DF1ED-AEC3-4D8D-908C-22206EE09C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356228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5391367-8383-4B19-94B2-A3D50F130D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FD1023F-F90C-4A67-9DEB-1DDAF39FA03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F54BB30-F4F3-4C68-8434-EC3692B3E0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CD2140-D9CC-416D-9F5F-B2A0957519B5}" type="datetimeFigureOut">
              <a:rPr lang="zh-CN" altLang="en-US" smtClean="0"/>
              <a:t>2021/10/2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A964333-4282-46B5-B8E1-B3EF138095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BBA699E-067C-47DE-9C61-9FE9D53ADD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DF1ED-AEC3-4D8D-908C-22206EE09C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199379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EB74CA82-F9B6-4861-9EFE-C37231E107D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1977C1A-3605-4F51-95AA-C82CC25B7CA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576F652-EB8B-4C79-9705-35E215CCF7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CD2140-D9CC-416D-9F5F-B2A0957519B5}" type="datetimeFigureOut">
              <a:rPr lang="zh-CN" altLang="en-US" smtClean="0"/>
              <a:t>2021/10/2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E246437-0B9B-4343-8BDB-71C014660C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8C2C144-3200-424E-AE98-2649FC20A0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DF1ED-AEC3-4D8D-908C-22206EE09C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256525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D93819F-47C3-44F1-AFAA-172EFDE273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81B14DE-7E8D-443D-9590-E5C476A4156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2E16E4E-1BD5-4661-A577-EA10E1E261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CD2140-D9CC-416D-9F5F-B2A0957519B5}" type="datetimeFigureOut">
              <a:rPr lang="zh-CN" altLang="en-US" smtClean="0"/>
              <a:t>2021/10/2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38AF9BC-22CA-4155-B50D-2583D96245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EB10623-B480-4987-A3ED-DD6374166F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DF1ED-AEC3-4D8D-908C-22206EE09C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432995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1E50B2C-7CC6-4142-A8D7-C8361B6BE0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ED95EBD-6F54-4869-A3D8-87542126DD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BEB3B2E-5BBB-4AE5-856F-3294EEC262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CD2140-D9CC-416D-9F5F-B2A0957519B5}" type="datetimeFigureOut">
              <a:rPr lang="zh-CN" altLang="en-US" smtClean="0"/>
              <a:t>2021/10/2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1CCE59B-93F0-4106-8D14-D0959170EC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EAFC60D-6DA4-446C-800A-767C7BD9D6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DF1ED-AEC3-4D8D-908C-22206EE09C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889163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E7E7BA4-9A7B-459B-921C-B3622FD672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8A62C31-60B3-475B-8527-9088CA55541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8C592E5-F3F0-4BC8-8B98-976EC5D81F2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317164C-CA3F-4B0E-B413-A15D6111A4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CD2140-D9CC-416D-9F5F-B2A0957519B5}" type="datetimeFigureOut">
              <a:rPr lang="zh-CN" altLang="en-US" smtClean="0"/>
              <a:t>2021/10/2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595466D-B86E-483D-8788-373432C9F9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168988F-4F3C-4E4B-B1E8-9BDA33CA73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DF1ED-AEC3-4D8D-908C-22206EE09C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15969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3FF34AF-F37F-46CD-91C4-C8F84F0EEE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62DC027-A83C-4C7E-BAB0-1F440D1DA9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108E055-CFB3-4B61-97A6-9519EC428C9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C18128F8-8EE2-47DC-A948-DDA7D5C12F9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3DB4055-6544-4ED1-86A3-97CE19D09B1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B29F3439-675A-4BB4-9B9A-F3C1A3DC35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CD2140-D9CC-416D-9F5F-B2A0957519B5}" type="datetimeFigureOut">
              <a:rPr lang="zh-CN" altLang="en-US" smtClean="0"/>
              <a:t>2021/10/25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422503A7-30E6-4DF0-BD2A-D737B86337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086ABB7F-8DF6-42B9-AB38-97D610CB22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DF1ED-AEC3-4D8D-908C-22206EE09C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954357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2D1BCE9-412B-40CB-A52B-D3D573F133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2F90BAFA-13DB-4895-9FE7-2FCBEDD411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CD2140-D9CC-416D-9F5F-B2A0957519B5}" type="datetimeFigureOut">
              <a:rPr lang="zh-CN" altLang="en-US" smtClean="0"/>
              <a:t>2021/10/25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2185B1FA-30CB-490F-9F13-5321FCA3DE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F06A8236-88FA-41BF-AD4B-294F097963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DF1ED-AEC3-4D8D-908C-22206EE09C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396980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4349569E-1B83-4F96-AFE3-1FC2338AD2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CD2140-D9CC-416D-9F5F-B2A0957519B5}" type="datetimeFigureOut">
              <a:rPr lang="zh-CN" altLang="en-US" smtClean="0"/>
              <a:t>2021/10/25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DBDC044F-E606-4727-8629-4D640ED0F8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E11402A4-BB1A-4935-939A-985A4B644A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DF1ED-AEC3-4D8D-908C-22206EE09C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35475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82F3BC4-EF95-4826-B9C3-ACEA5A22F1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1C5BDCC-C6A2-4773-ADAE-FE5E8AEAE5E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7720E5D-099B-4DFE-9FEB-F8C0F9BF5C3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9A854F2-95BD-4861-99A7-993BEA9218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CD2140-D9CC-416D-9F5F-B2A0957519B5}" type="datetimeFigureOut">
              <a:rPr lang="zh-CN" altLang="en-US" smtClean="0"/>
              <a:t>2021/10/2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3670442-0B68-4E8D-8601-026C22274C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7BCD285-ADE6-4F36-BF4E-349DC43026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DF1ED-AEC3-4D8D-908C-22206EE09C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54374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C0E577B-6C7D-42A8-ADE7-7A504BEBD3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447DE351-0C4F-4EA0-A10B-B023E1F4F09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0565A27-7E94-429E-8CF9-8D30BFC0AB0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AA0A93A-C280-44D3-AE6A-74ED0D34C9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CD2140-D9CC-416D-9F5F-B2A0957519B5}" type="datetimeFigureOut">
              <a:rPr lang="zh-CN" altLang="en-US" smtClean="0"/>
              <a:t>2021/10/2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B54D510-3C5E-4C00-BD74-27DFCD7E73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0D518EC-B9DF-48AD-8D5C-209851E948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DF1ED-AEC3-4D8D-908C-22206EE09C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252714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F4814E17-1DFE-4140-8449-5ED923C1D7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59191FB-D3AF-4F51-A180-C499A2B97C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BF528C7-1D01-4B63-A4E8-DC6FABFB4F7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CD2140-D9CC-416D-9F5F-B2A0957519B5}" type="datetimeFigureOut">
              <a:rPr lang="zh-CN" altLang="en-US" smtClean="0"/>
              <a:t>2021/10/2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162513B-7A4D-4C9E-836F-97AA29A9CC4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B3290B9-6F46-44C9-AF5B-474E369F9F6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CDF1ED-AEC3-4D8D-908C-22206EE09C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836307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7">
            <a:extLst>
              <a:ext uri="{FF2B5EF4-FFF2-40B4-BE49-F238E27FC236}">
                <a16:creationId xmlns:a16="http://schemas.microsoft.com/office/drawing/2014/main" id="{03500337-ED6F-4292-A66B-DEB6197CBF80}"/>
              </a:ext>
            </a:extLst>
          </p:cNvPr>
          <p:cNvSpPr txBox="1"/>
          <p:nvPr/>
        </p:nvSpPr>
        <p:spPr>
          <a:xfrm>
            <a:off x="469900" y="5802958"/>
            <a:ext cx="11518900" cy="10021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200000"/>
              </a:lnSpc>
            </a:pPr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.1a </a:t>
            </a:r>
            <a:r>
              <a:rPr lang="en-US" altLang="zh-CN" sz="1600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Sensitivity analysis for the association between OS and surgery approach. CI, confidence interval; OS, overall survival</a:t>
            </a:r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2C0D5002-B221-436D-AE98-053D9064783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15350" y="7097"/>
            <a:ext cx="8606117" cy="582347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780336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640D96B5-ED79-4AF1-8D49-4C20E02BD8C9}"/>
              </a:ext>
            </a:extLst>
          </p:cNvPr>
          <p:cNvSpPr txBox="1"/>
          <p:nvPr/>
        </p:nvSpPr>
        <p:spPr>
          <a:xfrm>
            <a:off x="469900" y="5736698"/>
            <a:ext cx="11518900" cy="10021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200000"/>
              </a:lnSpc>
            </a:pPr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.1b </a:t>
            </a:r>
            <a:r>
              <a:rPr lang="en-US" altLang="zh-CN" sz="1600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Sensitivity analysis for the association between post-operation complication rate and surgery approach. CI, confidence interval; OS, overall survival</a:t>
            </a:r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A496F5E7-0D56-45C3-8D31-71ED81BC67D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42243" y="12425"/>
            <a:ext cx="8901953" cy="59008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5964068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9DA66FD3-97C1-41CE-8ED2-60AD07036CBE}"/>
              </a:ext>
            </a:extLst>
          </p:cNvPr>
          <p:cNvSpPr txBox="1"/>
          <p:nvPr/>
        </p:nvSpPr>
        <p:spPr>
          <a:xfrm>
            <a:off x="469900" y="5763202"/>
            <a:ext cx="11518900" cy="10021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200000"/>
              </a:lnSpc>
            </a:pPr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.1c </a:t>
            </a:r>
            <a:r>
              <a:rPr lang="en-US" altLang="zh-CN" sz="1600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Sensitivity analysis for the association between total number of lymph node dissection and surgery approach. CI, confidence interval; OS, overall survival</a:t>
            </a:r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234F8721-523C-48E5-90BA-FB4E671B1E7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31684" y="0"/>
            <a:ext cx="8504948" cy="58824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6921340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A8C275C6-65FA-4F9D-9056-99E1B0D6A93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2794000" y="487817"/>
            <a:ext cx="6705600" cy="4869211"/>
          </a:xfrm>
          <a:prstGeom prst="rect">
            <a:avLst/>
          </a:prstGeom>
        </p:spPr>
      </p:pic>
      <p:sp>
        <p:nvSpPr>
          <p:cNvPr id="6" name="TextBox 7">
            <a:extLst>
              <a:ext uri="{FF2B5EF4-FFF2-40B4-BE49-F238E27FC236}">
                <a16:creationId xmlns:a16="http://schemas.microsoft.com/office/drawing/2014/main" id="{C043C9E6-B23A-44B6-B0E8-0F73D2E8A80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0" y="5516563"/>
            <a:ext cx="12099235" cy="19870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>
              <a:lnSpc>
                <a:spcPct val="200000"/>
              </a:lnSpc>
              <a:spcBef>
                <a:spcPct val="0"/>
              </a:spcBef>
              <a:buNone/>
            </a:pPr>
            <a:r>
              <a:rPr lang="en-US" altLang="zh-CN" sz="1600" b="1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Supplement figure. 2a </a:t>
            </a:r>
            <a:r>
              <a:rPr lang="en-US" altLang="zh-CN" sz="1600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Funnel plots showing the publication bias regarding the relationship between overall survival and the surgery approach. </a:t>
            </a:r>
            <a:br>
              <a:rPr lang="en-US" altLang="zh-CN" sz="1600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</a:br>
            <a:br>
              <a:rPr lang="en-US" altLang="zh-CN" sz="16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</a:br>
            <a:br>
              <a:rPr lang="en-US" altLang="zh-CN" sz="16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</a:br>
            <a:endParaRPr lang="zh-CN" altLang="en-US" sz="1600" b="1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3202537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E3510DC1-C495-4087-8471-83C260F4A28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14612" y="407987"/>
            <a:ext cx="6886575" cy="5000625"/>
          </a:xfrm>
          <a:prstGeom prst="rect">
            <a:avLst/>
          </a:prstGeom>
        </p:spPr>
      </p:pic>
      <p:sp>
        <p:nvSpPr>
          <p:cNvPr id="6" name="TextBox 7">
            <a:extLst>
              <a:ext uri="{FF2B5EF4-FFF2-40B4-BE49-F238E27FC236}">
                <a16:creationId xmlns:a16="http://schemas.microsoft.com/office/drawing/2014/main" id="{67FB2CDC-5074-4FA4-9084-AFBA92C9261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0" y="5516563"/>
            <a:ext cx="12187238" cy="2479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>
              <a:lnSpc>
                <a:spcPct val="200000"/>
              </a:lnSpc>
              <a:spcBef>
                <a:spcPct val="0"/>
              </a:spcBef>
              <a:buNone/>
            </a:pPr>
            <a:r>
              <a:rPr lang="en-US" altLang="zh-CN" sz="1600" b="1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Supplement figure. 2b </a:t>
            </a:r>
            <a:r>
              <a:rPr lang="en-US" altLang="zh-CN" sz="1600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Funnel plots showing the publication bias regarding the relationship between post-operation complication rate and the surgery approach. </a:t>
            </a:r>
            <a:br>
              <a:rPr lang="en-US" altLang="zh-CN" sz="1600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</a:br>
            <a:br>
              <a:rPr lang="en-US" altLang="zh-CN" sz="16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</a:br>
            <a:br>
              <a:rPr lang="en-US" altLang="zh-CN" sz="16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</a:br>
            <a:endParaRPr lang="zh-CN" altLang="en-US" sz="1600" b="1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6480390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5390996B-97F4-4849-B1FF-A0281451CE5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14612" y="420687"/>
            <a:ext cx="6886575" cy="5000625"/>
          </a:xfrm>
          <a:prstGeom prst="rect">
            <a:avLst/>
          </a:prstGeom>
        </p:spPr>
      </p:pic>
      <p:sp>
        <p:nvSpPr>
          <p:cNvPr id="6" name="TextBox 7">
            <a:extLst>
              <a:ext uri="{FF2B5EF4-FFF2-40B4-BE49-F238E27FC236}">
                <a16:creationId xmlns:a16="http://schemas.microsoft.com/office/drawing/2014/main" id="{6F19CEC8-196E-4E2A-B933-3540C8F28CA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0" y="5516563"/>
            <a:ext cx="12187238" cy="2479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>
              <a:lnSpc>
                <a:spcPct val="200000"/>
              </a:lnSpc>
              <a:spcBef>
                <a:spcPct val="0"/>
              </a:spcBef>
              <a:buNone/>
            </a:pPr>
            <a:r>
              <a:rPr lang="en-US" altLang="zh-CN" sz="1600" b="1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Supplement figure. 2c </a:t>
            </a:r>
            <a:r>
              <a:rPr lang="en-US" altLang="zh-CN" sz="1600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Funnel plots showing the publication bias regarding the relationship between total number of lymph node dissection and the surgery approach. </a:t>
            </a:r>
            <a:br>
              <a:rPr lang="en-US" altLang="zh-CN" sz="1600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</a:br>
            <a:br>
              <a:rPr lang="en-US" altLang="zh-CN" sz="16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</a:br>
            <a:br>
              <a:rPr lang="en-US" altLang="zh-CN" sz="16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</a:br>
            <a:endParaRPr lang="zh-CN" altLang="en-US" sz="1600" b="1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578854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0</TotalTime>
  <Words>156</Words>
  <Application>Microsoft Office PowerPoint</Application>
  <PresentationFormat>宽屏</PresentationFormat>
  <Paragraphs>6</Paragraphs>
  <Slides>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1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Administrator</cp:lastModifiedBy>
  <cp:revision>13</cp:revision>
  <dcterms:created xsi:type="dcterms:W3CDTF">2021-05-09T10:57:37Z</dcterms:created>
  <dcterms:modified xsi:type="dcterms:W3CDTF">2021-10-24T16:43:27Z</dcterms:modified>
</cp:coreProperties>
</file>